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  <p:sldId id="263" r:id="rId3"/>
    <p:sldId id="264" r:id="rId4"/>
    <p:sldId id="265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364"/>
    <p:restoredTop sz="94673"/>
  </p:normalViewPr>
  <p:slideViewPr>
    <p:cSldViewPr snapToGrid="0">
      <p:cViewPr varScale="1">
        <p:scale>
          <a:sx n="85" d="100"/>
          <a:sy n="85" d="100"/>
        </p:scale>
        <p:origin x="192" y="7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2FDD3C-9108-17E9-D320-7A629D36D7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5C3FA76-A8F9-4BA9-FE05-B8FD5E5FB2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238AE2-907F-E453-8A59-A8CFD6FC1B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E2979-C370-DB47-AAAD-993525D459A2}" type="datetimeFigureOut">
              <a:rPr lang="en-US" smtClean="0"/>
              <a:t>12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2B0869-4CF7-0A23-FCC0-C02D305E52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765AE0-14AF-467E-F4BE-1DAB9D3BD9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FC983-8F83-984E-816A-04125BCCE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6830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4B9AD7-A4AE-E7AA-74B5-C5E68B9002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3A9931-86A8-F989-8652-656D5C89C2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DFF4DB-4DB2-A3EB-AE9C-2808ED8675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E2979-C370-DB47-AAAD-993525D459A2}" type="datetimeFigureOut">
              <a:rPr lang="en-US" smtClean="0"/>
              <a:t>12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E8F234-1793-128D-9BBF-0BCC0F9753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7294F4-E950-E4AA-9EE3-C373842671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FC983-8F83-984E-816A-04125BCCE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41933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3964F6C-F506-8DCC-752D-EEA9375B5A9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F509FD-9C12-68D9-8ACD-4328ED2EC4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0A2708-9FD4-95DE-C7E3-43BF4B1070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E2979-C370-DB47-AAAD-993525D459A2}" type="datetimeFigureOut">
              <a:rPr lang="en-US" smtClean="0"/>
              <a:t>12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5E0BE1-CC06-F970-96B8-3CE224CC0A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EB406B-EFD3-A05A-25AE-68BC97060E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FC983-8F83-984E-816A-04125BCCE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70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820F31-7F10-1F00-1D69-1A05D2A98D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1CB1CE-56BA-7B65-08F0-B8D6FE9712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7FEC73-9309-178A-D7ED-B28E20121E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E2979-C370-DB47-AAAD-993525D459A2}" type="datetimeFigureOut">
              <a:rPr lang="en-US" smtClean="0"/>
              <a:t>12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FB1BEF-1706-8A9A-8847-4CB11D940B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AA266B-444B-B32B-78E2-64571646AE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FC983-8F83-984E-816A-04125BCCE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750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3080EC-64C7-0AFB-1F40-2CDA2C6730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499AC2-0071-6378-654F-3A32D8ECF4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CC5988-895F-8D92-D08E-396823D96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E2979-C370-DB47-AAAD-993525D459A2}" type="datetimeFigureOut">
              <a:rPr lang="en-US" smtClean="0"/>
              <a:t>12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C3B838-E597-730B-610C-4B695F389D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DE5CDF-E778-C4A9-B5FF-CDC663DB26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FC983-8F83-984E-816A-04125BCCE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496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0B5662-8AB5-D10C-CB21-9B8350B164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0C6DB0-C13B-3159-59B1-62564A3FF6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18BD0E-F831-4C7E-4BFE-AAE89E95DD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8BDF2A-6281-35B4-A5E5-49A502134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E2979-C370-DB47-AAAD-993525D459A2}" type="datetimeFigureOut">
              <a:rPr lang="en-US" smtClean="0"/>
              <a:t>12/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D26687-FDE5-DF63-C45A-F9240B780E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34ACA1-A95D-440A-704D-A753903F41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FC983-8F83-984E-816A-04125BCCE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3091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ACCAC7-7EDD-C431-185F-1055A92E7B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49A1D7-8E75-4ACC-D4DA-1BC409FBCB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54BA00-A978-BBFB-4BBA-454FD21C8D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42CC1AA-507B-DD7A-2F6A-82B9AB68316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4F3F7F1-8FDF-B4D0-62AF-E1E2B4F3530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BC4E549-20D8-282A-1FE9-09EBCD24AC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E2979-C370-DB47-AAAD-993525D459A2}" type="datetimeFigureOut">
              <a:rPr lang="en-US" smtClean="0"/>
              <a:t>12/1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4A66BA7-BD35-5B0B-A62C-6405F40AF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853647E-FE8A-EDAD-B034-200E11B9F2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FC983-8F83-984E-816A-04125BCCE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325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B05C48-8631-63A5-BEED-0688261CA4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B01AB42-AA33-F331-ADF9-D149AD5BCD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E2979-C370-DB47-AAAD-993525D459A2}" type="datetimeFigureOut">
              <a:rPr lang="en-US" smtClean="0"/>
              <a:t>12/1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54A07A1-1E7D-50ED-1FDE-4CEA679A63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6EA6B61-3F01-DA11-E2A5-14B040021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FC983-8F83-984E-816A-04125BCCE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5042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9C6F827-F6BD-E4C2-BA2C-9B1CDCA54C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E2979-C370-DB47-AAAD-993525D459A2}" type="datetimeFigureOut">
              <a:rPr lang="en-US" smtClean="0"/>
              <a:t>12/1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914C68-171A-2BEB-F423-2228C117C0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EB98F3B-F1CB-A1CB-98ED-E007812483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FC983-8F83-984E-816A-04125BCCE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441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099692-3CFA-98FB-30B4-8CA866C9D8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E2074A-7CC8-F93A-7FDE-3A721CA08B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BFD3E90-256F-386A-3AAB-B52E076A63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4BDCF1-4543-F75D-D26F-5C4CD6B0C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E2979-C370-DB47-AAAD-993525D459A2}" type="datetimeFigureOut">
              <a:rPr lang="en-US" smtClean="0"/>
              <a:t>12/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ECA441-D0F1-C274-2D70-57311E5FD0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CB6621-65BE-C74A-BD39-3359C6B7DC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FC983-8F83-984E-816A-04125BCCE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31842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8BBBA8-6B30-EC35-1E94-3F043F8703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E39A2B9-391B-E205-E09E-9F9F2F4F9C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8360200-DD4D-6C47-0AA9-F67BEEB1E0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F1AA59-E879-8940-175D-19B7B770EC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E2979-C370-DB47-AAAD-993525D459A2}" type="datetimeFigureOut">
              <a:rPr lang="en-US" smtClean="0"/>
              <a:t>12/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F6B897-6CBB-FFAA-8214-16C4B1AC85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F1DCF4-C0C5-A9D8-D80A-C8994AF2A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FC983-8F83-984E-816A-04125BCCE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136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F14250B-4C1E-2A96-1C34-91E91486C7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B1192A-87F7-DF26-6175-6A7AD914BB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5618B2-9347-6526-55D4-4B9D1C985CD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CAE2979-C370-DB47-AAAD-993525D459A2}" type="datetimeFigureOut">
              <a:rPr lang="en-US" smtClean="0"/>
              <a:t>12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A9E40C-3C24-88E8-CE9D-CAB0D92140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065A4F-C9E8-095D-E747-4FF8485BC08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2FC983-8F83-984E-816A-04125BCCEE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348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4728446F-2DE3-5722-5A40-C23C6A924E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24250" y="0"/>
            <a:ext cx="5143500" cy="456270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409C0C3-FFE8-F3B2-D9C8-955F9848D0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08182" y="4562703"/>
            <a:ext cx="1159568" cy="2088248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B2588DD6-E212-4913-8DE5-CDDFC4842021}"/>
              </a:ext>
            </a:extLst>
          </p:cNvPr>
          <p:cNvSpPr txBox="1"/>
          <p:nvPr/>
        </p:nvSpPr>
        <p:spPr>
          <a:xfrm>
            <a:off x="7798697" y="6581001"/>
            <a:ext cx="109388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1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DCA85AE1-1FC1-6818-3218-18E7CDC07D7A}"/>
              </a:ext>
            </a:extLst>
          </p:cNvPr>
          <p:cNvGraphicFramePr>
            <a:graphicFrameLocks noGrp="1"/>
          </p:cNvGraphicFramePr>
          <p:nvPr/>
        </p:nvGraphicFramePr>
        <p:xfrm>
          <a:off x="4127175" y="4805131"/>
          <a:ext cx="2842071" cy="192603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47357">
                  <a:extLst>
                    <a:ext uri="{9D8B030D-6E8A-4147-A177-3AD203B41FA5}">
                      <a16:colId xmlns:a16="http://schemas.microsoft.com/office/drawing/2014/main" val="1416053065"/>
                    </a:ext>
                  </a:extLst>
                </a:gridCol>
                <a:gridCol w="947357">
                  <a:extLst>
                    <a:ext uri="{9D8B030D-6E8A-4147-A177-3AD203B41FA5}">
                      <a16:colId xmlns:a16="http://schemas.microsoft.com/office/drawing/2014/main" val="1447674946"/>
                    </a:ext>
                  </a:extLst>
                </a:gridCol>
                <a:gridCol w="947357">
                  <a:extLst>
                    <a:ext uri="{9D8B030D-6E8A-4147-A177-3AD203B41FA5}">
                      <a16:colId xmlns:a16="http://schemas.microsoft.com/office/drawing/2014/main" val="3181055017"/>
                    </a:ext>
                  </a:extLst>
                </a:gridCol>
              </a:tblGrid>
              <a:tr h="38862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Gen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q-valu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Expr Log Ratio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821597292"/>
                  </a:ext>
                </a:extLst>
              </a:tr>
              <a:tr h="253696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PRF1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0.00247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4.204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416284726"/>
                  </a:ext>
                </a:extLst>
              </a:tr>
              <a:tr h="253696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FASLG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0.0091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2.695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1259546934"/>
                  </a:ext>
                </a:extLst>
              </a:tr>
              <a:tr h="253696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KLRD1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0.0442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2.611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2479011200"/>
                  </a:ext>
                </a:extLst>
              </a:tr>
              <a:tr h="253696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CD69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0.0197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2.578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3061953461"/>
                  </a:ext>
                </a:extLst>
              </a:tr>
              <a:tr h="253696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CAMK2B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0.0401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-1.093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3639052848"/>
                  </a:ext>
                </a:extLst>
              </a:tr>
              <a:tr h="253696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CSF2RB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0.00595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-1.597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627357003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A6F0F6B9-19D1-EB7D-C355-7760D8A07FB8}"/>
              </a:ext>
            </a:extLst>
          </p:cNvPr>
          <p:cNvSpPr txBox="1"/>
          <p:nvPr/>
        </p:nvSpPr>
        <p:spPr>
          <a:xfrm>
            <a:off x="3609975" y="2843213"/>
            <a:ext cx="11430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Dendritic cell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3E78BA0-D400-FFE4-03E8-2642C4D46D04}"/>
              </a:ext>
            </a:extLst>
          </p:cNvPr>
          <p:cNvSpPr txBox="1"/>
          <p:nvPr/>
        </p:nvSpPr>
        <p:spPr>
          <a:xfrm>
            <a:off x="3609975" y="518105"/>
            <a:ext cx="11430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Natural killer cell</a:t>
            </a:r>
          </a:p>
        </p:txBody>
      </p:sp>
    </p:spTree>
    <p:extLst>
      <p:ext uri="{BB962C8B-B14F-4D97-AF65-F5344CB8AC3E}">
        <p14:creationId xmlns:p14="http://schemas.microsoft.com/office/powerpoint/2010/main" val="17976249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B8717F9-6B98-A7F7-38DF-193FD68E92AB}"/>
              </a:ext>
            </a:extLst>
          </p:cNvPr>
          <p:cNvSpPr txBox="1"/>
          <p:nvPr/>
        </p:nvSpPr>
        <p:spPr>
          <a:xfrm>
            <a:off x="7798697" y="6581001"/>
            <a:ext cx="109388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2</a:t>
            </a:r>
          </a:p>
        </p:txBody>
      </p:sp>
      <p:pic>
        <p:nvPicPr>
          <p:cNvPr id="5" name="Picture 4" descr="A diagram of a network&#10;&#10;AI-generated content may be incorrect.">
            <a:extLst>
              <a:ext uri="{FF2B5EF4-FFF2-40B4-BE49-F238E27FC236}">
                <a16:creationId xmlns:a16="http://schemas.microsoft.com/office/drawing/2014/main" id="{FB0BDF78-52C2-98E9-C7D2-533F6FF2191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18" b="2116"/>
          <a:stretch>
            <a:fillRect/>
          </a:stretch>
        </p:blipFill>
        <p:spPr>
          <a:xfrm>
            <a:off x="3524250" y="106669"/>
            <a:ext cx="5143500" cy="410908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2F6B153-07C6-12D1-8708-9B17956595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08182" y="4492753"/>
            <a:ext cx="1159568" cy="2088248"/>
          </a:xfrm>
          <a:prstGeom prst="rect">
            <a:avLst/>
          </a:prstGeom>
        </p:spPr>
      </p:pic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DDDBE14A-914C-DFEF-757A-01F3727E3D5D}"/>
              </a:ext>
            </a:extLst>
          </p:cNvPr>
          <p:cNvGraphicFramePr>
            <a:graphicFrameLocks noGrp="1"/>
          </p:cNvGraphicFramePr>
          <p:nvPr/>
        </p:nvGraphicFramePr>
        <p:xfrm>
          <a:off x="4232909" y="4389119"/>
          <a:ext cx="3050439" cy="24058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16813">
                  <a:extLst>
                    <a:ext uri="{9D8B030D-6E8A-4147-A177-3AD203B41FA5}">
                      <a16:colId xmlns:a16="http://schemas.microsoft.com/office/drawing/2014/main" val="1416053065"/>
                    </a:ext>
                  </a:extLst>
                </a:gridCol>
                <a:gridCol w="1016813">
                  <a:extLst>
                    <a:ext uri="{9D8B030D-6E8A-4147-A177-3AD203B41FA5}">
                      <a16:colId xmlns:a16="http://schemas.microsoft.com/office/drawing/2014/main" val="1447674946"/>
                    </a:ext>
                  </a:extLst>
                </a:gridCol>
                <a:gridCol w="1016813">
                  <a:extLst>
                    <a:ext uri="{9D8B030D-6E8A-4147-A177-3AD203B41FA5}">
                      <a16:colId xmlns:a16="http://schemas.microsoft.com/office/drawing/2014/main" val="3181055017"/>
                    </a:ext>
                  </a:extLst>
                </a:gridCol>
              </a:tblGrid>
              <a:tr h="383334">
                <a:tc>
                  <a:txBody>
                    <a:bodyPr/>
                    <a:lstStyle/>
                    <a:p>
                      <a:pPr algn="ctr"/>
                      <a:r>
                        <a:rPr lang="en-US" sz="1100" b="1" kern="1200" dirty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Gen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kern="1200" dirty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q-valu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kern="1200" dirty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Expr Log Ratio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821597292"/>
                  </a:ext>
                </a:extLst>
              </a:tr>
              <a:tr h="25024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SOCS1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00598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-1.649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416284726"/>
                  </a:ext>
                </a:extLst>
              </a:tr>
              <a:tr h="25024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CSF2RB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00595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-1.597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1259546934"/>
                  </a:ext>
                </a:extLst>
              </a:tr>
              <a:tr h="25024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IL22RA1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0407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-1.123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2479011200"/>
                  </a:ext>
                </a:extLst>
              </a:tr>
              <a:tr h="25024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MAP3K9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0174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-1.05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3061953461"/>
                  </a:ext>
                </a:extLst>
              </a:tr>
              <a:tr h="25024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IL4R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00744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-1.009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3639052848"/>
                  </a:ext>
                </a:extLst>
              </a:tr>
              <a:tr h="25024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FGFR1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0182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-0.787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627357003"/>
                  </a:ext>
                </a:extLst>
              </a:tr>
              <a:tr h="25024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KDR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0151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-0.64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1316620728"/>
                  </a:ext>
                </a:extLst>
              </a:tr>
              <a:tr h="25024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IL6R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00247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-0.602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3351454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726132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01AF08EE-1FC6-C485-0EC5-E02ED02647CB}"/>
              </a:ext>
            </a:extLst>
          </p:cNvPr>
          <p:cNvSpPr txBox="1"/>
          <p:nvPr/>
        </p:nvSpPr>
        <p:spPr>
          <a:xfrm>
            <a:off x="7798697" y="6581001"/>
            <a:ext cx="109388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3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992410EA-E5F6-28F1-FE3D-EAD53CE059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88831" y="4165471"/>
            <a:ext cx="1159568" cy="2088248"/>
          </a:xfrm>
          <a:prstGeom prst="rect">
            <a:avLst/>
          </a:prstGeom>
        </p:spPr>
      </p:pic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A37F7CF1-59FD-E01A-4821-F463F3D66247}"/>
              </a:ext>
            </a:extLst>
          </p:cNvPr>
          <p:cNvGraphicFramePr>
            <a:graphicFrameLocks noGrp="1"/>
          </p:cNvGraphicFramePr>
          <p:nvPr/>
        </p:nvGraphicFramePr>
        <p:xfrm>
          <a:off x="4300344" y="4354619"/>
          <a:ext cx="2696334" cy="165508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98778">
                  <a:extLst>
                    <a:ext uri="{9D8B030D-6E8A-4147-A177-3AD203B41FA5}">
                      <a16:colId xmlns:a16="http://schemas.microsoft.com/office/drawing/2014/main" val="1416053065"/>
                    </a:ext>
                  </a:extLst>
                </a:gridCol>
                <a:gridCol w="898778">
                  <a:extLst>
                    <a:ext uri="{9D8B030D-6E8A-4147-A177-3AD203B41FA5}">
                      <a16:colId xmlns:a16="http://schemas.microsoft.com/office/drawing/2014/main" val="1447674946"/>
                    </a:ext>
                  </a:extLst>
                </a:gridCol>
                <a:gridCol w="898778">
                  <a:extLst>
                    <a:ext uri="{9D8B030D-6E8A-4147-A177-3AD203B41FA5}">
                      <a16:colId xmlns:a16="http://schemas.microsoft.com/office/drawing/2014/main" val="3181055017"/>
                    </a:ext>
                  </a:extLst>
                </a:gridCol>
              </a:tblGrid>
              <a:tr h="388620">
                <a:tc>
                  <a:txBody>
                    <a:bodyPr/>
                    <a:lstStyle/>
                    <a:p>
                      <a:pPr algn="ctr"/>
                      <a:r>
                        <a:rPr lang="en-US" sz="1100" b="0" i="0" u="none" strike="noStrike" kern="12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Gen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i="0" u="none" strike="noStrike" kern="12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q-valu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i="0" u="none" strike="noStrike" kern="12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Expr Log Ratio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821597292"/>
                  </a:ext>
                </a:extLst>
              </a:tr>
              <a:tr h="25024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Gzmn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0.0289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6.201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416284726"/>
                  </a:ext>
                </a:extLst>
              </a:tr>
              <a:tr h="25024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PRF1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0.00247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4.204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1259546934"/>
                  </a:ext>
                </a:extLst>
              </a:tr>
              <a:tr h="25024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Gzmb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0.00598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3.837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2479011200"/>
                  </a:ext>
                </a:extLst>
              </a:tr>
              <a:tr h="25024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Gzmc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0.00765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3.817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3061953461"/>
                  </a:ext>
                </a:extLst>
              </a:tr>
              <a:tr h="25024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GZMH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0.00592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3.799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3639052848"/>
                  </a:ext>
                </a:extLst>
              </a:tr>
            </a:tbl>
          </a:graphicData>
        </a:graphic>
      </p:graphicFrame>
      <p:pic>
        <p:nvPicPr>
          <p:cNvPr id="10" name="Picture 9">
            <a:extLst>
              <a:ext uri="{FF2B5EF4-FFF2-40B4-BE49-F238E27FC236}">
                <a16:creationId xmlns:a16="http://schemas.microsoft.com/office/drawing/2014/main" id="{E4841588-1AF1-6C38-283C-94756D98B19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27269" y="393286"/>
            <a:ext cx="4279786" cy="34449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225082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824B3A8-06B5-2D93-E2AD-2393F059DBED}"/>
              </a:ext>
            </a:extLst>
          </p:cNvPr>
          <p:cNvSpPr txBox="1"/>
          <p:nvPr/>
        </p:nvSpPr>
        <p:spPr>
          <a:xfrm>
            <a:off x="7798697" y="6581001"/>
            <a:ext cx="109388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4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90A72D5-03F6-07E6-804A-DA4F296CE8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01745" y="4323829"/>
            <a:ext cx="1159568" cy="2088248"/>
          </a:xfrm>
          <a:prstGeom prst="rect">
            <a:avLst/>
          </a:prstGeom>
        </p:spPr>
      </p:pic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307CDB55-72CB-778C-9D73-2DDC79FABDED}"/>
              </a:ext>
            </a:extLst>
          </p:cNvPr>
          <p:cNvGraphicFramePr>
            <a:graphicFrameLocks noGrp="1"/>
          </p:cNvGraphicFramePr>
          <p:nvPr/>
        </p:nvGraphicFramePr>
        <p:xfrm>
          <a:off x="4078145" y="4521987"/>
          <a:ext cx="2696334" cy="19053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98778">
                  <a:extLst>
                    <a:ext uri="{9D8B030D-6E8A-4147-A177-3AD203B41FA5}">
                      <a16:colId xmlns:a16="http://schemas.microsoft.com/office/drawing/2014/main" val="1416053065"/>
                    </a:ext>
                  </a:extLst>
                </a:gridCol>
                <a:gridCol w="898778">
                  <a:extLst>
                    <a:ext uri="{9D8B030D-6E8A-4147-A177-3AD203B41FA5}">
                      <a16:colId xmlns:a16="http://schemas.microsoft.com/office/drawing/2014/main" val="1447674946"/>
                    </a:ext>
                  </a:extLst>
                </a:gridCol>
                <a:gridCol w="898778">
                  <a:extLst>
                    <a:ext uri="{9D8B030D-6E8A-4147-A177-3AD203B41FA5}">
                      <a16:colId xmlns:a16="http://schemas.microsoft.com/office/drawing/2014/main" val="3181055017"/>
                    </a:ext>
                  </a:extLst>
                </a:gridCol>
              </a:tblGrid>
              <a:tr h="388620">
                <a:tc>
                  <a:txBody>
                    <a:bodyPr/>
                    <a:lstStyle/>
                    <a:p>
                      <a:pPr algn="ctr"/>
                      <a:r>
                        <a:rPr lang="en-US" sz="1100" b="0" i="0" u="none" strike="noStrike" kern="12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Gen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i="0" u="none" strike="noStrike" kern="12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q-valu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i="0" u="none" strike="noStrike" kern="12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Expr Log Ratio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821597292"/>
                  </a:ext>
                </a:extLst>
              </a:tr>
              <a:tr h="25024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PRF1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0.00247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4.204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416284726"/>
                  </a:ext>
                </a:extLst>
              </a:tr>
              <a:tr h="25024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FASLG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0.0091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2.695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1259546934"/>
                  </a:ext>
                </a:extLst>
              </a:tr>
              <a:tr h="25024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EOMES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0.0407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1.773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2479011200"/>
                  </a:ext>
                </a:extLst>
              </a:tr>
              <a:tr h="25024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IL23A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0.0388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1.637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3061953461"/>
                  </a:ext>
                </a:extLst>
              </a:tr>
              <a:tr h="25024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effectLst/>
                          <a:latin typeface="Arial" panose="020B0604020202020204" pitchFamily="34" charset="0"/>
                        </a:rPr>
                        <a:t>CLEC7A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0.00592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0.993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3639052848"/>
                  </a:ext>
                </a:extLst>
              </a:tr>
              <a:tr h="25024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IL6R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0.00247</a:t>
                      </a: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</a:rPr>
                        <a:t>-0.602</a:t>
                      </a: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2765102213"/>
                  </a:ext>
                </a:extLst>
              </a:tr>
            </a:tbl>
          </a:graphicData>
        </a:graphic>
      </p:graphicFrame>
      <p:pic>
        <p:nvPicPr>
          <p:cNvPr id="10" name="Picture 9">
            <a:extLst>
              <a:ext uri="{FF2B5EF4-FFF2-40B4-BE49-F238E27FC236}">
                <a16:creationId xmlns:a16="http://schemas.microsoft.com/office/drawing/2014/main" id="{64DB2660-8B29-C96D-D5CF-807FBB73FEBD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7848"/>
          <a:stretch>
            <a:fillRect/>
          </a:stretch>
        </p:blipFill>
        <p:spPr>
          <a:xfrm>
            <a:off x="3917289" y="77040"/>
            <a:ext cx="3711028" cy="38430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57628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19</Words>
  <Application>Microsoft Macintosh PowerPoint</Application>
  <PresentationFormat>Widescreen</PresentationFormat>
  <Paragraphs>9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oy, Sabita</dc:creator>
  <cp:lastModifiedBy>Roy, Sabita</cp:lastModifiedBy>
  <cp:revision>1</cp:revision>
  <dcterms:created xsi:type="dcterms:W3CDTF">2025-12-01T17:36:00Z</dcterms:created>
  <dcterms:modified xsi:type="dcterms:W3CDTF">2025-12-01T17:37:23Z</dcterms:modified>
</cp:coreProperties>
</file>